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30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6C7C0D-3AEF-47A6-8634-A80E05B91B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9965E6F-56A4-4B23-9278-134924B7DA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A81072-D330-4AAD-9374-FD05F1761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00EDF4-5C7F-497F-8D08-F95BFDF06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2FFADD-1ED3-4A9D-A36B-F6D1D2270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5298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66CF89-C29A-445B-BFA1-67CEE59B5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75F56FE-FDE3-4671-8389-BA590D79D7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4F60FD-85BE-48A2-BD27-90385EA50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7FF3EF-21C9-4426-B42D-0BDF9845B4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43A453-20C4-459A-9896-068B4801D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772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1B0FE96-502A-44A1-BB88-FAFA52FC9A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FD7A67-02B7-4759-B506-D4368E8B1B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7BE187-F9B9-47F3-823E-EB83A8C7B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9CCAE9-EE9B-48A2-B138-2FFB2F662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63233A-1185-4C88-AC48-E1DA7BD65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4567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5DD659-7093-493C-BB0A-17817161D6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EC4BC46-20DD-420E-88AE-3BCE2ACC80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2EA336-BD56-4468-8ADE-A52D3C475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57BA3A-087E-490A-BB36-7F858EFD15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6BDA7F-BC58-4669-82D6-EDCD20C9B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95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614223-20AC-4847-BEBA-7221048CFB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ED45A0F-C02C-4C8B-A54C-2826B196AB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FBB53F-18E9-4534-BB42-D60DA98C6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74BEFB-AAE5-469F-BE25-E8E22E3E4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0C2473-9C2A-42A3-BC70-FD07EAE5A1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9350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586F36-F3B7-422B-ADC0-0629E83544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8AFBFBD-5170-49CB-A0F9-5250EE7F96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A6F3168-7CFA-4A3B-9CB5-6441062C22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160F6EE-8A08-4222-86C4-E68FE2CD72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000A2DA-A007-414F-BD86-775E0BBFF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38DDE0E-DB80-4765-8A81-126EE9458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206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3D94B8-A38C-42A4-B004-42F57ECC8B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B7CB757-F70F-4B15-9ECB-82D0B4AC03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B591ACB-6ABF-4A8A-8BA4-4B9AB7861D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31734A4-F651-4AE4-AE26-B82AC13639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3C2C27B-B0CA-41FD-BB0D-187542007C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04E3E82-0D9F-4D68-B4EB-B3221A521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A80EFB1-A2E4-4A93-9165-38E0E5103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61856A7-83CC-4F7F-A4BD-D74BCA5B7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1146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1A4243-1E1D-429A-9276-B2ACEE2DE9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86E0F66-09DA-4DAE-9909-28496B18FE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6354B45-A04C-412D-80F0-9A8D1F3F6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B0B0217-3976-4013-8FAF-6E57F867E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5662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6E0CDFE-1916-4C72-98C1-77F576DF8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98C1925-464F-4061-8A8A-2E00B84687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FEA95A-0973-4C44-92F8-79A323F81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2568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38A8DA-FA87-4EE5-BBB6-E53B17EDD4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C0F9316-66DB-4282-9F1F-CC92818107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AF263A-FC59-4C52-B5E1-1052BAAC30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28D06AE-27C2-49B6-B797-043ADD4AF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453AFC4-2D9B-427D-9330-2ECC550A6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974B4C-5D30-4D52-A24C-DCB53F59E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6940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7BC1F8-1ABC-44EE-8A05-2191CD5765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27CE0D7-EEAD-44C8-A83D-E1633D6DAD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DB4C9F9-A817-4456-8DFE-AD7180A67D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63BCC2D-9E97-4780-B64D-F690F39F9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0ED0810-6C77-446E-9254-40FDE24163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510D07-8A4F-4910-9D08-FCB53004E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7395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F4A4713-26EC-4B9F-AD58-6B773DAFA0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4FD448-BD54-45C2-AA49-D661256215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A27BD6-2E94-4776-BE6E-E8A6BD6C22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C1C07-CCC7-4A97-9F58-00534087C6A6}" type="datetimeFigureOut">
              <a:rPr lang="zh-CN" altLang="en-US" smtClean="0"/>
              <a:t>2020-5-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8FC8A5-6A22-4618-8C54-BF196E6FA5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B89A29-2F85-471D-9579-CD1E8D001A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4D990-C396-4F95-87DE-BD305E2BCB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0794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矩形 8">
            <a:extLst>
              <a:ext uri="{FF2B5EF4-FFF2-40B4-BE49-F238E27FC236}">
                <a16:creationId xmlns:a16="http://schemas.microsoft.com/office/drawing/2014/main" id="{42EB7432-FADA-4166-8DB8-9A8C86194CDF}"/>
              </a:ext>
            </a:extLst>
          </p:cNvPr>
          <p:cNvSpPr/>
          <p:nvPr/>
        </p:nvSpPr>
        <p:spPr>
          <a:xfrm>
            <a:off x="2038737" y="4631942"/>
            <a:ext cx="8859595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kern="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Leukocyte 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DNA copy number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b="1" kern="0" dirty="0" err="1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mtDNAcn</a:t>
            </a:r>
            <a:r>
              <a:rPr lang="en-US" altLang="zh-CN" b="1" kern="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and inflammation markers (A),and oxidative stress markers(B) of participants with 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 glucose tolerance (NGT, n=128) and abnormal glucose tolerance(AGT, n=190).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were presented as mean ± standard deviation. SOD, superoxide dismutase; GR, glutathione reductase; 8-oxo-dG, 8-oxo-2′-deoxyguanosine; TNF-α, tumor necrosis factor-α; IL-6, interleukin-6 </a:t>
            </a:r>
            <a:endParaRPr lang="zh-CN" altLang="zh-CN" sz="1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42BD077-8A53-4B8C-8EA0-0B2A35FAC1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5820" y="1335702"/>
            <a:ext cx="2880360" cy="2950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7583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0</TotalTime>
  <Words>83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池发 马</dc:creator>
  <cp:lastModifiedBy>池发 马</cp:lastModifiedBy>
  <cp:revision>8</cp:revision>
  <dcterms:created xsi:type="dcterms:W3CDTF">2020-03-05T14:35:40Z</dcterms:created>
  <dcterms:modified xsi:type="dcterms:W3CDTF">2020-05-14T19:08:56Z</dcterms:modified>
</cp:coreProperties>
</file>